
<file path=[Content_Types].xml><?xml version="1.0" encoding="utf-8"?>
<Types xmlns="http://schemas.openxmlformats.org/package/2006/content-types">
  <Default Extension="gif" ContentType="image/gi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295DA8E-D90D-4289-819F-2B371CC4CFC3}" v="2" dt="2023-07-30T01:14:32.34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2" d="100"/>
          <a:sy n="42" d="100"/>
        </p:scale>
        <p:origin x="2280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RIYA RANI" userId="168e54ad-9b2c-4b18-be83-178c2e373f06" providerId="ADAL" clId="{3295DA8E-D90D-4289-819F-2B371CC4CFC3}"/>
    <pc:docChg chg="custSel addSld delSld modSld">
      <pc:chgData name="PRIYA RANI" userId="168e54ad-9b2c-4b18-be83-178c2e373f06" providerId="ADAL" clId="{3295DA8E-D90D-4289-819F-2B371CC4CFC3}" dt="2023-07-30T01:14:41.009" v="3" actId="478"/>
      <pc:docMkLst>
        <pc:docMk/>
      </pc:docMkLst>
      <pc:sldChg chg="new del">
        <pc:chgData name="PRIYA RANI" userId="168e54ad-9b2c-4b18-be83-178c2e373f06" providerId="ADAL" clId="{3295DA8E-D90D-4289-819F-2B371CC4CFC3}" dt="2023-07-30T01:14:34.408" v="2" actId="47"/>
        <pc:sldMkLst>
          <pc:docMk/>
          <pc:sldMk cId="2396371128" sldId="256"/>
        </pc:sldMkLst>
      </pc:sldChg>
      <pc:sldChg chg="delSp add mod">
        <pc:chgData name="PRIYA RANI" userId="168e54ad-9b2c-4b18-be83-178c2e373f06" providerId="ADAL" clId="{3295DA8E-D90D-4289-819F-2B371CC4CFC3}" dt="2023-07-30T01:14:41.009" v="3" actId="478"/>
        <pc:sldMkLst>
          <pc:docMk/>
          <pc:sldMk cId="4093768208" sldId="257"/>
        </pc:sldMkLst>
        <pc:spChg chg="del">
          <ac:chgData name="PRIYA RANI" userId="168e54ad-9b2c-4b18-be83-178c2e373f06" providerId="ADAL" clId="{3295DA8E-D90D-4289-819F-2B371CC4CFC3}" dt="2023-07-30T01:14:41.009" v="3" actId="478"/>
          <ac:spMkLst>
            <pc:docMk/>
            <pc:sldMk cId="4093768208" sldId="257"/>
            <ac:spMk id="2" creationId="{01B0B5EA-A5A6-D201-3EE9-D6692572C8B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F576-0A25-47AC-820C-9F6577153435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5CB63-56B4-4969-85D9-D025EBB1FAA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3594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F576-0A25-47AC-820C-9F6577153435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5CB63-56B4-4969-85D9-D025EBB1FAA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28076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F576-0A25-47AC-820C-9F6577153435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5CB63-56B4-4969-85D9-D025EBB1FAA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76523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F576-0A25-47AC-820C-9F6577153435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5CB63-56B4-4969-85D9-D025EBB1FAA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330163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F576-0A25-47AC-820C-9F6577153435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5CB63-56B4-4969-85D9-D025EBB1FAA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661756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F576-0A25-47AC-820C-9F6577153435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5CB63-56B4-4969-85D9-D025EBB1FAA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381854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F576-0A25-47AC-820C-9F6577153435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5CB63-56B4-4969-85D9-D025EBB1FAA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046763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F576-0A25-47AC-820C-9F6577153435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5CB63-56B4-4969-85D9-D025EBB1FAA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91257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F576-0A25-47AC-820C-9F6577153435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5CB63-56B4-4969-85D9-D025EBB1FAA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07087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F576-0A25-47AC-820C-9F6577153435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5CB63-56B4-4969-85D9-D025EBB1FAA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490290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CF576-0A25-47AC-820C-9F6577153435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5CB63-56B4-4969-85D9-D025EBB1FAA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123186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7CF576-0A25-47AC-820C-9F6577153435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A5CB63-56B4-4969-85D9-D025EBB1FAA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631520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F78AC74-0C9E-3F61-2D27-B664A8FE582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9173" b="67588"/>
          <a:stretch/>
        </p:blipFill>
        <p:spPr bwMode="auto">
          <a:xfrm>
            <a:off x="361184" y="845690"/>
            <a:ext cx="6135632" cy="7064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65B9EE4-8707-7E3B-C03C-4B71EEAE795A}"/>
              </a:ext>
            </a:extLst>
          </p:cNvPr>
          <p:cNvSpPr txBox="1"/>
          <p:nvPr/>
        </p:nvSpPr>
        <p:spPr>
          <a:xfrm>
            <a:off x="361184" y="1901190"/>
            <a:ext cx="6135632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S1 Confirmation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of miR-22 Knockout in HeLa cells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Genomic DNA was isolated from WT and miR-22 KO HeLa cells. miR-22 synthesizing DNA region was amplified by PCR and the PCR product was used for DNA sequencing. The DNA sequences from miR-22 KO cells, WT cells and the miR-22 stem loop sequence were aligned using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ultAlin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software.</a:t>
            </a:r>
            <a:endParaRPr lang="en-IN" sz="1200" dirty="0"/>
          </a:p>
        </p:txBody>
      </p:sp>
    </p:spTree>
    <p:extLst>
      <p:ext uri="{BB962C8B-B14F-4D97-AF65-F5344CB8AC3E}">
        <p14:creationId xmlns:p14="http://schemas.microsoft.com/office/powerpoint/2010/main" val="40937682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62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IYA RANI</dc:creator>
  <cp:lastModifiedBy>PRIYA RANI</cp:lastModifiedBy>
  <cp:revision>1</cp:revision>
  <dcterms:created xsi:type="dcterms:W3CDTF">2023-07-30T01:14:06Z</dcterms:created>
  <dcterms:modified xsi:type="dcterms:W3CDTF">2023-07-30T01:14:43Z</dcterms:modified>
</cp:coreProperties>
</file>